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A9F30-817C-497E-B40A-4A3B4D255E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375E5-9B73-4F87-9222-96243364E9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C6D978-7EA5-41EB-8927-811DF86B99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FB804-EDD9-45C1-9A53-DE448A8809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8E42A-6EF2-4DB0-AF2E-0A68A3FA88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7C538-A5C0-4DEE-ACDE-E37701FEB5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457EA-E6B8-42F5-B297-E00F08B4E4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34ED0-1480-4D3C-96B7-2FFEF99D8A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A29AB-A598-4FE5-837E-0B1E8F257C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114AA-70FD-4FCE-8C67-105E128DF5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FA29A-671D-4920-B77E-FA0F58EA41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621D1F-5995-4755-A5DC-ACD5F390AF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0D1E52-BECB-4A2A-9F3D-1069DCFAD32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0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6"/>
          <p:cNvSpPr/>
          <p:nvPr/>
        </p:nvSpPr>
        <p:spPr>
          <a:xfrm>
            <a:off x="448200" y="758880"/>
            <a:ext cx="87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-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7"/>
          <p:cNvSpPr/>
          <p:nvPr/>
        </p:nvSpPr>
        <p:spPr>
          <a:xfrm>
            <a:off x="1753560" y="758880"/>
            <a:ext cx="109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-SN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8"/>
          <p:cNvSpPr/>
          <p:nvPr/>
        </p:nvSpPr>
        <p:spPr>
          <a:xfrm>
            <a:off x="3311280" y="758880"/>
            <a:ext cx="98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-A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9"/>
          <p:cNvSpPr/>
          <p:nvPr/>
        </p:nvSpPr>
        <p:spPr>
          <a:xfrm>
            <a:off x="4677120" y="758880"/>
            <a:ext cx="118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-SN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20"/>
          <p:cNvSpPr/>
          <p:nvPr/>
        </p:nvSpPr>
        <p:spPr>
          <a:xfrm>
            <a:off x="6287760" y="758880"/>
            <a:ext cx="99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-C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1"/>
          <p:cNvSpPr/>
          <p:nvPr/>
        </p:nvSpPr>
        <p:spPr>
          <a:xfrm>
            <a:off x="7742160" y="758880"/>
            <a:ext cx="100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CT116-G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2"/>
          <p:cNvSpPr/>
          <p:nvPr/>
        </p:nvSpPr>
        <p:spPr>
          <a:xfrm>
            <a:off x="1096920" y="2789280"/>
            <a:ext cx="487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36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± 7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3"/>
          <p:cNvSpPr/>
          <p:nvPr/>
        </p:nvSpPr>
        <p:spPr>
          <a:xfrm>
            <a:off x="2538360" y="2782800"/>
            <a:ext cx="412920" cy="51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23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  <a:ea typeface="Arial"/>
              </a:rPr>
              <a:t>± 2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4"/>
          <p:cNvSpPr/>
          <p:nvPr/>
        </p:nvSpPr>
        <p:spPr>
          <a:xfrm>
            <a:off x="4113360" y="2787480"/>
            <a:ext cx="425160" cy="48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6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±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5"/>
          <p:cNvSpPr/>
          <p:nvPr/>
        </p:nvSpPr>
        <p:spPr>
          <a:xfrm>
            <a:off x="5543640" y="2787480"/>
            <a:ext cx="463320" cy="48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5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± 1.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6"/>
          <p:cNvSpPr/>
          <p:nvPr/>
        </p:nvSpPr>
        <p:spPr>
          <a:xfrm>
            <a:off x="6977160" y="2784600"/>
            <a:ext cx="476280" cy="43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13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±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9"/>
          <p:cNvSpPr/>
          <p:nvPr/>
        </p:nvSpPr>
        <p:spPr>
          <a:xfrm>
            <a:off x="8497800" y="2784600"/>
            <a:ext cx="50184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10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±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0"/>
          <p:cNvSpPr/>
          <p:nvPr/>
        </p:nvSpPr>
        <p:spPr>
          <a:xfrm>
            <a:off x="270360" y="490680"/>
            <a:ext cx="849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Not 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1"/>
          <p:cNvSpPr/>
          <p:nvPr/>
        </p:nvSpPr>
        <p:spPr>
          <a:xfrm>
            <a:off x="227520" y="2592360"/>
            <a:ext cx="960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N38-tre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1"/>
          <a:stretch/>
        </p:blipFill>
        <p:spPr>
          <a:xfrm>
            <a:off x="208080" y="979560"/>
            <a:ext cx="1434960" cy="14396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6" descr=""/>
          <p:cNvPicPr/>
          <p:nvPr/>
        </p:nvPicPr>
        <p:blipFill>
          <a:blip r:embed="rId2"/>
          <a:stretch/>
        </p:blipFill>
        <p:spPr>
          <a:xfrm>
            <a:off x="1636560" y="979560"/>
            <a:ext cx="1435320" cy="14396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8" descr=""/>
          <p:cNvPicPr/>
          <p:nvPr/>
        </p:nvPicPr>
        <p:blipFill>
          <a:blip r:embed="rId3"/>
          <a:stretch/>
        </p:blipFill>
        <p:spPr>
          <a:xfrm>
            <a:off x="3137040" y="979560"/>
            <a:ext cx="1434960" cy="14396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0" descr=""/>
          <p:cNvPicPr/>
          <p:nvPr/>
        </p:nvPicPr>
        <p:blipFill>
          <a:blip r:embed="rId4"/>
          <a:stretch/>
        </p:blipFill>
        <p:spPr>
          <a:xfrm>
            <a:off x="4565520" y="979560"/>
            <a:ext cx="1435320" cy="143964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2" descr=""/>
          <p:cNvPicPr/>
          <p:nvPr/>
        </p:nvPicPr>
        <p:blipFill>
          <a:blip r:embed="rId5"/>
          <a:stretch/>
        </p:blipFill>
        <p:spPr>
          <a:xfrm>
            <a:off x="6066000" y="979560"/>
            <a:ext cx="1434960" cy="14396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4" descr=""/>
          <p:cNvPicPr/>
          <p:nvPr/>
        </p:nvPicPr>
        <p:blipFill>
          <a:blip r:embed="rId6"/>
          <a:stretch/>
        </p:blipFill>
        <p:spPr>
          <a:xfrm>
            <a:off x="7494480" y="979560"/>
            <a:ext cx="1435320" cy="143964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5" descr=""/>
          <p:cNvPicPr/>
          <p:nvPr/>
        </p:nvPicPr>
        <p:blipFill>
          <a:blip r:embed="rId7"/>
          <a:stretch/>
        </p:blipFill>
        <p:spPr>
          <a:xfrm>
            <a:off x="231840" y="2778120"/>
            <a:ext cx="1434960" cy="14400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7" descr=""/>
          <p:cNvPicPr/>
          <p:nvPr/>
        </p:nvPicPr>
        <p:blipFill>
          <a:blip r:embed="rId8"/>
          <a:stretch/>
        </p:blipFill>
        <p:spPr>
          <a:xfrm>
            <a:off x="1660680" y="2778120"/>
            <a:ext cx="1434960" cy="14400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9" descr=""/>
          <p:cNvPicPr/>
          <p:nvPr/>
        </p:nvPicPr>
        <p:blipFill>
          <a:blip r:embed="rId9"/>
          <a:stretch/>
        </p:blipFill>
        <p:spPr>
          <a:xfrm>
            <a:off x="3160800" y="2778120"/>
            <a:ext cx="1434960" cy="144000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1" descr=""/>
          <p:cNvPicPr/>
          <p:nvPr/>
        </p:nvPicPr>
        <p:blipFill>
          <a:blip r:embed="rId10"/>
          <a:stretch/>
        </p:blipFill>
        <p:spPr>
          <a:xfrm>
            <a:off x="4589640" y="2778120"/>
            <a:ext cx="1434960" cy="144000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13" descr=""/>
          <p:cNvPicPr/>
          <p:nvPr/>
        </p:nvPicPr>
        <p:blipFill>
          <a:blip r:embed="rId11"/>
          <a:stretch/>
        </p:blipFill>
        <p:spPr>
          <a:xfrm>
            <a:off x="6089760" y="2778120"/>
            <a:ext cx="1434960" cy="144000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5" descr=""/>
          <p:cNvPicPr/>
          <p:nvPr/>
        </p:nvPicPr>
        <p:blipFill>
          <a:blip r:embed="rId12"/>
          <a:stretch/>
        </p:blipFill>
        <p:spPr>
          <a:xfrm>
            <a:off x="7518240" y="2778120"/>
            <a:ext cx="1435320" cy="1440000"/>
          </a:xfrm>
          <a:prstGeom prst="rect">
            <a:avLst/>
          </a:prstGeom>
          <a:ln w="0">
            <a:noFill/>
          </a:ln>
        </p:spPr>
      </p:pic>
      <p:sp>
        <p:nvSpPr>
          <p:cNvPr id="67" name="Rectangle 61"/>
          <p:cNvSpPr/>
          <p:nvPr/>
        </p:nvSpPr>
        <p:spPr>
          <a:xfrm>
            <a:off x="942840" y="3479760"/>
            <a:ext cx="71136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3.7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7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62"/>
          <p:cNvSpPr/>
          <p:nvPr/>
        </p:nvSpPr>
        <p:spPr>
          <a:xfrm>
            <a:off x="2409480" y="3479760"/>
            <a:ext cx="61524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8.0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5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63"/>
          <p:cNvSpPr/>
          <p:nvPr/>
        </p:nvSpPr>
        <p:spPr>
          <a:xfrm>
            <a:off x="3962880" y="3479760"/>
            <a:ext cx="57240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.9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64"/>
          <p:cNvSpPr/>
          <p:nvPr/>
        </p:nvSpPr>
        <p:spPr>
          <a:xfrm>
            <a:off x="5330520" y="3479760"/>
            <a:ext cx="61524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.4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4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65"/>
          <p:cNvSpPr/>
          <p:nvPr/>
        </p:nvSpPr>
        <p:spPr>
          <a:xfrm>
            <a:off x="6910560" y="3479760"/>
            <a:ext cx="52956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.4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1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66"/>
          <p:cNvSpPr/>
          <p:nvPr/>
        </p:nvSpPr>
        <p:spPr>
          <a:xfrm>
            <a:off x="8259480" y="3479760"/>
            <a:ext cx="6577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.5%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71440" y="4706280"/>
            <a:ext cx="82962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: Assessment of DNA double strand break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formation by measuring H2AX phosphorylation in SN38 sensitive and resistant HCT116 cells treated or not with SN38. Phosphorylated H2AX quantification was performed by flow cytometry analysis. Cells were plated (1 x 105 cells) in 6-well plates and 48 hours later, cells were incubated with 5 µM SN38 for 1 hour. Further FACS experiments were performed as described in Methods.  % indicates the number of cells with fluorescence intensity &gt; 2 x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Data represent the mean ± SD of at least 3 independent experime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8T09:34:28Z</dcterms:created>
  <dc:creator>DEL RIO</dc:creator>
  <dc:description/>
  <dc:language>en-US</dc:language>
  <cp:lastModifiedBy>DEL RIO</cp:lastModifiedBy>
  <dcterms:modified xsi:type="dcterms:W3CDTF">2011-04-29T10:16:07Z</dcterms:modified>
  <cp:revision>2</cp:revision>
  <dc:subject/>
  <dc:title>Diapositive 1</dc:title>
</cp:coreProperties>
</file>